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51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84626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035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27158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5785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14354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203075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2823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9484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204599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916398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85272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51FAFF-DD23-46EC-94CC-D13BD2ED2D6A}" type="datetimeFigureOut">
              <a:rPr lang="it-IT" smtClean="0"/>
              <a:t>10/09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500D7B-5F5B-478E-81F8-AAA9441B881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94675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5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88029" y="260648"/>
            <a:ext cx="5818036" cy="48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ttangolo 2"/>
          <p:cNvSpPr/>
          <p:nvPr/>
        </p:nvSpPr>
        <p:spPr>
          <a:xfrm>
            <a:off x="251520" y="5157192"/>
            <a:ext cx="8712968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focal microscopy analysis of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ysoTraker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stained infected THP-1-derived macrophage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ative images of cells infected with GFP expressing H37Rv, TB218 (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ig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utant) or TB382 (complemented strain) at an MOI of 1:1. After 48 h of infection, cells were stained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ysoTrake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red)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calizati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both red and green fluorescence indicates that the mycobacteria reside in acidic compartments. The overlap is demonstrated in the merged images, where yellow indicates a positive correlation. Boxed area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how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largements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ction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terest with examples of negative (H37Rv and TB318) and positive (TB218)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ocalizatio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ages were taken with a Leica T CSNT/SP2 confocal microscope using a x63 oil immersion objective. To calculate the percentage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calizatio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each coverslip, the superposition of fluorescence for a minimum of 100 internalized isolated bacteria was analyzed. At least two slides were analyzed from each of three independent infections. 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83543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64</Words>
  <Application>Microsoft Office PowerPoint</Application>
  <PresentationFormat>Presentazione su schermo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iccardo</dc:creator>
  <cp:lastModifiedBy>Riccardo</cp:lastModifiedBy>
  <cp:revision>2</cp:revision>
  <dcterms:created xsi:type="dcterms:W3CDTF">2014-09-09T22:22:12Z</dcterms:created>
  <dcterms:modified xsi:type="dcterms:W3CDTF">2014-09-09T22:23:32Z</dcterms:modified>
</cp:coreProperties>
</file>